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326" r:id="rId2"/>
    <p:sldId id="327" r:id="rId3"/>
    <p:sldId id="328" r:id="rId4"/>
  </p:sldIdLst>
  <p:sldSz cx="9144000" cy="6858000" type="screen4x3"/>
  <p:notesSz cx="6805613" cy="9944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F90BB9A-AE53-4648-B388-08F732FFFC18}">
          <p14:sldIdLst>
            <p14:sldId id="326"/>
            <p14:sldId id="327"/>
            <p14:sldId id="328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eghmde" initials="Marco DP" lastIdx="5" clrIdx="0"/>
  <p:cmAuthor id="1" name="Nathwani, Amit (Medsch Royal Free/Haematology)" initials="NA(RF" lastIdx="5" clrIdx="1"/>
  <p:cmAuthor id="2" name="Satyen Gohil" initials="SG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914" autoAdjust="0"/>
    <p:restoredTop sz="87922" autoAdjust="0"/>
  </p:normalViewPr>
  <p:slideViewPr>
    <p:cSldViewPr>
      <p:cViewPr varScale="1">
        <p:scale>
          <a:sx n="92" d="100"/>
          <a:sy n="92" d="100"/>
        </p:scale>
        <p:origin x="-180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2" d="100"/>
        <a:sy n="18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9629" cy="497523"/>
          </a:xfrm>
          <a:prstGeom prst="rect">
            <a:avLst/>
          </a:prstGeom>
        </p:spPr>
        <p:txBody>
          <a:bodyPr vert="horz" lIns="91561" tIns="45780" rIns="91561" bIns="4578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4396" y="1"/>
            <a:ext cx="2949629" cy="497523"/>
          </a:xfrm>
          <a:prstGeom prst="rect">
            <a:avLst/>
          </a:prstGeom>
        </p:spPr>
        <p:txBody>
          <a:bodyPr vert="horz" lIns="91561" tIns="45780" rIns="91561" bIns="45780" rtlCol="0"/>
          <a:lstStyle>
            <a:lvl1pPr algn="r">
              <a:defRPr sz="1200"/>
            </a:lvl1pPr>
          </a:lstStyle>
          <a:p>
            <a:fld id="{2D272AB1-B020-4D67-9B08-AE1E59713F1C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9444989"/>
            <a:ext cx="2949629" cy="497523"/>
          </a:xfrm>
          <a:prstGeom prst="rect">
            <a:avLst/>
          </a:prstGeom>
        </p:spPr>
        <p:txBody>
          <a:bodyPr vert="horz" lIns="91561" tIns="45780" rIns="91561" bIns="4578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4396" y="9444989"/>
            <a:ext cx="2949629" cy="497523"/>
          </a:xfrm>
          <a:prstGeom prst="rect">
            <a:avLst/>
          </a:prstGeom>
        </p:spPr>
        <p:txBody>
          <a:bodyPr vert="horz" lIns="91561" tIns="45780" rIns="91561" bIns="45780" rtlCol="0" anchor="b"/>
          <a:lstStyle>
            <a:lvl1pPr algn="r">
              <a:defRPr sz="1200"/>
            </a:lvl1pPr>
          </a:lstStyle>
          <a:p>
            <a:fld id="{286DEAAC-AE8E-4685-977C-6F656EF30A0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724370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099" cy="497205"/>
          </a:xfrm>
          <a:prstGeom prst="rect">
            <a:avLst/>
          </a:prstGeom>
        </p:spPr>
        <p:txBody>
          <a:bodyPr vert="horz" lIns="91561" tIns="45780" rIns="91561" bIns="45780" rtlCol="0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4941" y="0"/>
            <a:ext cx="2949099" cy="497205"/>
          </a:xfrm>
          <a:prstGeom prst="rect">
            <a:avLst/>
          </a:prstGeom>
        </p:spPr>
        <p:txBody>
          <a:bodyPr vert="horz" lIns="91561" tIns="45780" rIns="91561" bIns="45780" rtlCol="0"/>
          <a:lstStyle>
            <a:lvl1pPr algn="r">
              <a:defRPr sz="1200"/>
            </a:lvl1pPr>
          </a:lstStyle>
          <a:p>
            <a:fld id="{08D57F5B-01C5-4F9A-B5D5-760782333EAA}" type="datetimeFigureOut">
              <a:rPr lang="it-IT" smtClean="0"/>
              <a:t>27/06/2017</a:t>
            </a:fld>
            <a:endParaRPr lang="it-IT" dirty="0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5988" y="746125"/>
            <a:ext cx="497363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61" tIns="45780" rIns="91561" bIns="45780" rtlCol="0" anchor="ctr"/>
          <a:lstStyle/>
          <a:p>
            <a:endParaRPr lang="it-IT" dirty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0562" y="4723449"/>
            <a:ext cx="5444490" cy="4474845"/>
          </a:xfrm>
          <a:prstGeom prst="rect">
            <a:avLst/>
          </a:prstGeom>
        </p:spPr>
        <p:txBody>
          <a:bodyPr vert="horz" lIns="91561" tIns="45780" rIns="91561" bIns="4578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1" y="9445170"/>
            <a:ext cx="2949099" cy="497205"/>
          </a:xfrm>
          <a:prstGeom prst="rect">
            <a:avLst/>
          </a:prstGeom>
        </p:spPr>
        <p:txBody>
          <a:bodyPr vert="horz" lIns="91561" tIns="45780" rIns="91561" bIns="45780" rtlCol="0" anchor="b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4941" y="9445170"/>
            <a:ext cx="2949099" cy="497205"/>
          </a:xfrm>
          <a:prstGeom prst="rect">
            <a:avLst/>
          </a:prstGeom>
        </p:spPr>
        <p:txBody>
          <a:bodyPr vert="horz" lIns="91561" tIns="45780" rIns="91561" bIns="45780" rtlCol="0" anchor="b"/>
          <a:lstStyle>
            <a:lvl1pPr algn="r">
              <a:defRPr sz="1200"/>
            </a:lvl1pPr>
          </a:lstStyle>
          <a:p>
            <a:fld id="{54642F0E-95BB-46B1-8357-65E094DA2EE0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8858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91160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38807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47895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17052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93308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20803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45217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39156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6699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18572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34892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7A250-33D0-417C-99D9-58E46795C656}" type="datetimeFigureOut">
              <a:rPr lang="en-GB" smtClean="0"/>
              <a:t>27/06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8C6D9-F213-41B0-B0D1-17F9FCB4A1F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44333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0" y="0"/>
            <a:ext cx="3491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1</a:t>
            </a:r>
            <a:endParaRPr lang="en-GB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4328" y="650828"/>
            <a:ext cx="5235344" cy="555634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066321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0" y="0"/>
            <a:ext cx="3491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2</a:t>
            </a:r>
            <a:endParaRPr lang="en-GB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18477" y="7554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/>
          </p:nvPr>
        </p:nvGraphicFramePr>
        <p:xfrm>
          <a:off x="6739566" y="1095392"/>
          <a:ext cx="2117725" cy="3136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4" name="Prism 7" r:id="rId3" imgW="2117598" imgH="3137662" progId="Prism7.Document">
                  <p:embed/>
                </p:oleObj>
              </mc:Choice>
              <mc:Fallback>
                <p:oleObj name="Prism 7" r:id="rId3" imgW="2117598" imgH="313766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39566" y="1095392"/>
                        <a:ext cx="2117725" cy="3136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3581901" y="7554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807389" y="75541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3347864" y="1124744"/>
          <a:ext cx="3078163" cy="3119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Prism 7" r:id="rId5" imgW="3078080" imgH="3119294" progId="Prism7.Document">
                  <p:embed/>
                </p:oleObj>
              </mc:Choice>
              <mc:Fallback>
                <p:oleObj name="Prism 7" r:id="rId5" imgW="3078080" imgH="311929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47864" y="1124744"/>
                        <a:ext cx="3078163" cy="3119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349862" y="1080748"/>
          <a:ext cx="2684463" cy="34015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6" name="Prism 7" r:id="rId7" imgW="2684812" imgH="3357356" progId="Prism7.Document">
                  <p:embed/>
                </p:oleObj>
              </mc:Choice>
              <mc:Fallback>
                <p:oleObj name="Prism 7" r:id="rId7" imgW="2684812" imgH="335735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9862" y="1080748"/>
                        <a:ext cx="2684463" cy="34015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510453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330" y="980728"/>
            <a:ext cx="7670959" cy="85677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766806" y="6926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i="1" dirty="0" smtClean="0"/>
              <a:t>1.6</a:t>
            </a:r>
            <a:endParaRPr lang="en-GB" sz="1200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2609869" y="6926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i="1" dirty="0" smtClean="0"/>
              <a:t>2.6</a:t>
            </a:r>
            <a:endParaRPr lang="en-GB" sz="1200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4887945" y="6926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i="1" dirty="0" smtClean="0"/>
              <a:t>2.6</a:t>
            </a:r>
            <a:endParaRPr lang="en-GB" sz="1200" i="1" dirty="0"/>
          </a:p>
        </p:txBody>
      </p:sp>
      <p:sp>
        <p:nvSpPr>
          <p:cNvPr id="20" name="TextBox 19"/>
          <p:cNvSpPr txBox="1"/>
          <p:nvPr/>
        </p:nvSpPr>
        <p:spPr>
          <a:xfrm>
            <a:off x="6041410" y="6926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i="1" dirty="0" smtClean="0"/>
              <a:t>3.6</a:t>
            </a:r>
            <a:endParaRPr lang="en-GB" sz="1200" i="1" dirty="0"/>
          </a:p>
        </p:txBody>
      </p:sp>
      <p:sp>
        <p:nvSpPr>
          <p:cNvPr id="24" name="TextBox 23"/>
          <p:cNvSpPr txBox="1"/>
          <p:nvPr/>
        </p:nvSpPr>
        <p:spPr>
          <a:xfrm>
            <a:off x="7137966" y="6926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i="1" dirty="0" smtClean="0"/>
              <a:t>4.9</a:t>
            </a:r>
            <a:endParaRPr lang="en-GB" sz="1200" i="1" dirty="0"/>
          </a:p>
        </p:txBody>
      </p:sp>
      <p:sp>
        <p:nvSpPr>
          <p:cNvPr id="25" name="TextBox 24"/>
          <p:cNvSpPr txBox="1"/>
          <p:nvPr/>
        </p:nvSpPr>
        <p:spPr>
          <a:xfrm>
            <a:off x="369468" y="6926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i="1" dirty="0" smtClean="0"/>
              <a:t>3.2</a:t>
            </a:r>
            <a:endParaRPr lang="en-GB" sz="1200" i="1" dirty="0"/>
          </a:p>
        </p:txBody>
      </p:sp>
      <p:sp>
        <p:nvSpPr>
          <p:cNvPr id="29" name="TextBox 28"/>
          <p:cNvSpPr txBox="1"/>
          <p:nvPr/>
        </p:nvSpPr>
        <p:spPr>
          <a:xfrm>
            <a:off x="1488873" y="69269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i="1" dirty="0" smtClean="0"/>
              <a:t>1.1</a:t>
            </a:r>
            <a:endParaRPr lang="en-GB" sz="1200" i="1" dirty="0"/>
          </a:p>
        </p:txBody>
      </p:sp>
      <p:sp>
        <p:nvSpPr>
          <p:cNvPr id="43" name="TextBox 42"/>
          <p:cNvSpPr txBox="1"/>
          <p:nvPr/>
        </p:nvSpPr>
        <p:spPr>
          <a:xfrm>
            <a:off x="0" y="0"/>
            <a:ext cx="3491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</a:t>
            </a:r>
            <a:r>
              <a:rPr lang="en-GB" b="1" smtClean="0"/>
              <a:t>Figure 3</a:t>
            </a:r>
            <a:endParaRPr lang="en-GB" b="1" dirty="0"/>
          </a:p>
        </p:txBody>
      </p:sp>
      <p:pic>
        <p:nvPicPr>
          <p:cNvPr id="32" name="Picture 14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2564904"/>
            <a:ext cx="5872521" cy="25675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3701884" y="1855857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A172</a:t>
            </a:r>
            <a:endParaRPr lang="en-GB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2540138" y="1855857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U251</a:t>
            </a:r>
            <a:endParaRPr lang="en-GB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4785353" y="185585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T618A</a:t>
            </a:r>
            <a:endParaRPr lang="en-GB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5924390" y="1855857"/>
            <a:ext cx="61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U145</a:t>
            </a:r>
            <a:endParaRPr lang="en-GB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7092280" y="1855857"/>
            <a:ext cx="4716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PC-3</a:t>
            </a:r>
            <a:endParaRPr lang="en-GB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179512" y="1855857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K-Hep-1</a:t>
            </a:r>
            <a:endParaRPr lang="en-GB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1378265" y="185585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HUH-7</a:t>
            </a:r>
            <a:endParaRPr lang="en-GB" sz="1200" dirty="0"/>
          </a:p>
        </p:txBody>
      </p:sp>
      <p:grpSp>
        <p:nvGrpSpPr>
          <p:cNvPr id="50" name="Group 49"/>
          <p:cNvGrpSpPr/>
          <p:nvPr/>
        </p:nvGrpSpPr>
        <p:grpSpPr>
          <a:xfrm rot="5400000">
            <a:off x="8123476" y="1775370"/>
            <a:ext cx="792088" cy="462245"/>
            <a:chOff x="276084" y="5862173"/>
            <a:chExt cx="792088" cy="462245"/>
          </a:xfrm>
        </p:grpSpPr>
        <p:sp>
          <p:nvSpPr>
            <p:cNvPr id="51" name="Rectangle 50"/>
            <p:cNvSpPr/>
            <p:nvPr/>
          </p:nvSpPr>
          <p:spPr>
            <a:xfrm rot="16200000">
              <a:off x="240080" y="6165304"/>
              <a:ext cx="144016" cy="72008"/>
            </a:xfrm>
            <a:prstGeom prst="rect">
              <a:avLst/>
            </a:prstGeom>
            <a:solidFill>
              <a:srgbClr val="FF99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" name="Rectangle 51"/>
            <p:cNvSpPr/>
            <p:nvPr/>
          </p:nvSpPr>
          <p:spPr>
            <a:xfrm rot="16200000">
              <a:off x="240080" y="5949280"/>
              <a:ext cx="144016" cy="72008"/>
            </a:xfrm>
            <a:prstGeom prst="rect">
              <a:avLst/>
            </a:prstGeom>
            <a:solidFill>
              <a:srgbClr val="66FF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32073" y="5862173"/>
              <a:ext cx="7360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Isotype Ab</a:t>
              </a:r>
              <a:endParaRPr lang="en-GB" sz="10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22522" y="6078197"/>
              <a:ext cx="6431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ROR1 Ab</a:t>
              </a:r>
              <a:endParaRPr lang="en-GB" sz="1000" dirty="0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8030561" y="866909"/>
            <a:ext cx="799008" cy="743540"/>
            <a:chOff x="5249715" y="6255082"/>
            <a:chExt cx="799008" cy="743540"/>
          </a:xfrm>
        </p:grpSpPr>
        <p:sp>
          <p:nvSpPr>
            <p:cNvPr id="56" name="TextBox 55"/>
            <p:cNvSpPr txBox="1"/>
            <p:nvPr/>
          </p:nvSpPr>
          <p:spPr>
            <a:xfrm rot="5400000">
              <a:off x="5073064" y="6431733"/>
              <a:ext cx="599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/>
                <a:t>Count</a:t>
              </a:r>
              <a:endParaRPr lang="en-GB" sz="1000" dirty="0"/>
            </a:p>
          </p:txBody>
        </p:sp>
        <p:cxnSp>
          <p:nvCxnSpPr>
            <p:cNvPr id="57" name="Straight Arrow Connector 56"/>
            <p:cNvCxnSpPr/>
            <p:nvPr/>
          </p:nvCxnSpPr>
          <p:spPr>
            <a:xfrm flipH="1" flipV="1">
              <a:off x="5462673" y="6278590"/>
              <a:ext cx="3067" cy="507233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/>
            <p:nvPr/>
          </p:nvCxnSpPr>
          <p:spPr>
            <a:xfrm>
              <a:off x="5463473" y="6785823"/>
              <a:ext cx="513242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5400651" y="6752401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/>
                <a:t>ROR1</a:t>
              </a:r>
              <a:endParaRPr lang="en-GB" sz="1000" dirty="0"/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8260453" y="907499"/>
            <a:ext cx="648072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i="1" dirty="0" smtClean="0"/>
              <a:t>Ratio </a:t>
            </a:r>
            <a:r>
              <a:rPr lang="en-GB" sz="700" i="1" dirty="0"/>
              <a:t>of ROR1 vs Isotype MFI</a:t>
            </a:r>
          </a:p>
          <a:p>
            <a:pPr algn="ctr"/>
            <a:endParaRPr lang="en-GB" sz="700" i="1" dirty="0"/>
          </a:p>
          <a:p>
            <a:pPr algn="ctr"/>
            <a:endParaRPr lang="en-GB" sz="700" i="1" dirty="0" smtClean="0"/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4"/>
          <a:srcRect t="84997"/>
          <a:stretch/>
        </p:blipFill>
        <p:spPr>
          <a:xfrm>
            <a:off x="1294816" y="5132412"/>
            <a:ext cx="7049177" cy="3722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7155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90</TotalTime>
  <Words>38</Words>
  <Application>Microsoft Office PowerPoint</Application>
  <PresentationFormat>On-screen Show (4:3)</PresentationFormat>
  <Paragraphs>25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7</vt:lpstr>
      <vt:lpstr>PowerPoint Presentation</vt:lpstr>
      <vt:lpstr>PowerPoint Presentation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ghmde</dc:creator>
  <cp:lastModifiedBy>Legaspi, Irene D.</cp:lastModifiedBy>
  <cp:revision>338</cp:revision>
  <cp:lastPrinted>2017-03-27T12:48:40Z</cp:lastPrinted>
  <dcterms:created xsi:type="dcterms:W3CDTF">2015-12-01T18:55:05Z</dcterms:created>
  <dcterms:modified xsi:type="dcterms:W3CDTF">2017-06-27T07:43:31Z</dcterms:modified>
</cp:coreProperties>
</file>